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3" d="100"/>
          <a:sy n="83" d="100"/>
        </p:scale>
        <p:origin x="125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13C95-6168-4EF6-B2E6-5C1702454BA3}" type="datetimeFigureOut">
              <a:rPr lang="en-CA" smtClean="0"/>
              <a:t>17/11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F58CB-9A7C-4E51-AD16-0B887BEE06E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18960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13C95-6168-4EF6-B2E6-5C1702454BA3}" type="datetimeFigureOut">
              <a:rPr lang="en-CA" smtClean="0"/>
              <a:t>17/11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F58CB-9A7C-4E51-AD16-0B887BEE06E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37634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13C95-6168-4EF6-B2E6-5C1702454BA3}" type="datetimeFigureOut">
              <a:rPr lang="en-CA" smtClean="0"/>
              <a:t>17/11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F58CB-9A7C-4E51-AD16-0B887BEE06E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40632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13C95-6168-4EF6-B2E6-5C1702454BA3}" type="datetimeFigureOut">
              <a:rPr lang="en-CA" smtClean="0"/>
              <a:t>17/11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F58CB-9A7C-4E51-AD16-0B887BEE06E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52944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13C95-6168-4EF6-B2E6-5C1702454BA3}" type="datetimeFigureOut">
              <a:rPr lang="en-CA" smtClean="0"/>
              <a:t>17/11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F58CB-9A7C-4E51-AD16-0B887BEE06E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91252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13C95-6168-4EF6-B2E6-5C1702454BA3}" type="datetimeFigureOut">
              <a:rPr lang="en-CA" smtClean="0"/>
              <a:t>17/11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F58CB-9A7C-4E51-AD16-0B887BEE06E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30467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13C95-6168-4EF6-B2E6-5C1702454BA3}" type="datetimeFigureOut">
              <a:rPr lang="en-CA" smtClean="0"/>
              <a:t>17/11/20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F58CB-9A7C-4E51-AD16-0B887BEE06E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59245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13C95-6168-4EF6-B2E6-5C1702454BA3}" type="datetimeFigureOut">
              <a:rPr lang="en-CA" smtClean="0"/>
              <a:t>17/11/20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F58CB-9A7C-4E51-AD16-0B887BEE06E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52585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13C95-6168-4EF6-B2E6-5C1702454BA3}" type="datetimeFigureOut">
              <a:rPr lang="en-CA" smtClean="0"/>
              <a:t>17/11/20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F58CB-9A7C-4E51-AD16-0B887BEE06E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50596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13C95-6168-4EF6-B2E6-5C1702454BA3}" type="datetimeFigureOut">
              <a:rPr lang="en-CA" smtClean="0"/>
              <a:t>17/11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F58CB-9A7C-4E51-AD16-0B887BEE06E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11694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13C95-6168-4EF6-B2E6-5C1702454BA3}" type="datetimeFigureOut">
              <a:rPr lang="en-CA" smtClean="0"/>
              <a:t>17/11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F58CB-9A7C-4E51-AD16-0B887BEE06E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601887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13C95-6168-4EF6-B2E6-5C1702454BA3}" type="datetimeFigureOut">
              <a:rPr lang="en-CA" smtClean="0"/>
              <a:t>17/11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F58CB-9A7C-4E51-AD16-0B887BEE06E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49093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666255" y="713982"/>
            <a:ext cx="11354295" cy="2534757"/>
            <a:chOff x="666255" y="915687"/>
            <a:chExt cx="11354295" cy="2534757"/>
          </a:xfrm>
        </p:grpSpPr>
        <p:grpSp>
          <p:nvGrpSpPr>
            <p:cNvPr id="5" name="Group 4"/>
            <p:cNvGrpSpPr/>
            <p:nvPr/>
          </p:nvGrpSpPr>
          <p:grpSpPr>
            <a:xfrm>
              <a:off x="10198359" y="2632788"/>
              <a:ext cx="1822191" cy="817656"/>
              <a:chOff x="10198359" y="3470988"/>
              <a:chExt cx="1822191" cy="817656"/>
            </a:xfrm>
          </p:grpSpPr>
          <p:sp>
            <p:nvSpPr>
              <p:cNvPr id="63" name="Rectangle 62"/>
              <p:cNvSpPr/>
              <p:nvPr/>
            </p:nvSpPr>
            <p:spPr>
              <a:xfrm>
                <a:off x="10198359" y="3470988"/>
                <a:ext cx="391886" cy="326571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10210794" y="3959290"/>
                <a:ext cx="391886" cy="32657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10606573" y="3476042"/>
                <a:ext cx="14139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stant regions</a:t>
                </a:r>
                <a:endParaRPr lang="en-CA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10606573" y="3980867"/>
                <a:ext cx="13569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iable regions</a:t>
                </a:r>
                <a:endParaRPr lang="en-CA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" name="Group 5"/>
            <p:cNvGrpSpPr/>
            <p:nvPr/>
          </p:nvGrpSpPr>
          <p:grpSpPr>
            <a:xfrm>
              <a:off x="666255" y="915687"/>
              <a:ext cx="10887895" cy="1260896"/>
              <a:chOff x="666255" y="915687"/>
              <a:chExt cx="10887895" cy="1260896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4221187" y="915687"/>
                <a:ext cx="6909253" cy="885127"/>
                <a:chOff x="4221187" y="915687"/>
                <a:chExt cx="6909253" cy="885127"/>
              </a:xfrm>
            </p:grpSpPr>
            <p:grpSp>
              <p:nvGrpSpPr>
                <p:cNvPr id="55" name="Group 54"/>
                <p:cNvGrpSpPr/>
                <p:nvPr/>
              </p:nvGrpSpPr>
              <p:grpSpPr>
                <a:xfrm>
                  <a:off x="4542743" y="1295406"/>
                  <a:ext cx="6346279" cy="505408"/>
                  <a:chOff x="4542743" y="1295406"/>
                  <a:chExt cx="6346279" cy="505408"/>
                </a:xfrm>
              </p:grpSpPr>
              <p:cxnSp>
                <p:nvCxnSpPr>
                  <p:cNvPr id="60" name="Straight Arrow Connector 59"/>
                  <p:cNvCxnSpPr/>
                  <p:nvPr/>
                </p:nvCxnSpPr>
                <p:spPr>
                  <a:xfrm>
                    <a:off x="8545872" y="1295406"/>
                    <a:ext cx="0" cy="505408"/>
                  </a:xfrm>
                  <a:prstGeom prst="straightConnector1">
                    <a:avLst/>
                  </a:prstGeom>
                  <a:ln w="28575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" name="Straight Arrow Connector 60"/>
                  <p:cNvCxnSpPr/>
                  <p:nvPr/>
                </p:nvCxnSpPr>
                <p:spPr>
                  <a:xfrm>
                    <a:off x="10889022" y="1295406"/>
                    <a:ext cx="0" cy="505408"/>
                  </a:xfrm>
                  <a:prstGeom prst="straightConnector1">
                    <a:avLst/>
                  </a:prstGeom>
                  <a:ln w="28575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" name="Straight Arrow Connector 61"/>
                  <p:cNvCxnSpPr/>
                  <p:nvPr/>
                </p:nvCxnSpPr>
                <p:spPr>
                  <a:xfrm>
                    <a:off x="4542743" y="1295406"/>
                    <a:ext cx="0" cy="505408"/>
                  </a:xfrm>
                  <a:prstGeom prst="straightConnector1">
                    <a:avLst/>
                  </a:prstGeom>
                  <a:ln w="28575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6" name="Group 55"/>
                <p:cNvGrpSpPr/>
                <p:nvPr/>
              </p:nvGrpSpPr>
              <p:grpSpPr>
                <a:xfrm>
                  <a:off x="4221187" y="915687"/>
                  <a:ext cx="6909253" cy="345877"/>
                  <a:chOff x="4187139" y="971556"/>
                  <a:chExt cx="6909253" cy="345877"/>
                </a:xfrm>
              </p:grpSpPr>
              <p:sp>
                <p:nvSpPr>
                  <p:cNvPr id="57" name="TextBox 56"/>
                  <p:cNvSpPr txBox="1"/>
                  <p:nvPr/>
                </p:nvSpPr>
                <p:spPr>
                  <a:xfrm>
                    <a:off x="4187139" y="971556"/>
                    <a:ext cx="6126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CA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8S-1</a:t>
                    </a:r>
                    <a:endParaRPr lang="en-CA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8" name="TextBox 57"/>
                  <p:cNvSpPr txBox="1"/>
                  <p:nvPr/>
                </p:nvSpPr>
                <p:spPr>
                  <a:xfrm>
                    <a:off x="8111999" y="990606"/>
                    <a:ext cx="6126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CA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8S-4</a:t>
                    </a:r>
                    <a:endParaRPr lang="en-CA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9" name="TextBox 58"/>
                  <p:cNvSpPr txBox="1"/>
                  <p:nvPr/>
                </p:nvSpPr>
                <p:spPr>
                  <a:xfrm>
                    <a:off x="10483724" y="1009656"/>
                    <a:ext cx="6126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CA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8S-5</a:t>
                    </a:r>
                    <a:endParaRPr lang="en-CA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grpSp>
            <p:nvGrpSpPr>
              <p:cNvPr id="8" name="Group 7"/>
              <p:cNvGrpSpPr/>
              <p:nvPr/>
            </p:nvGrpSpPr>
            <p:grpSpPr>
              <a:xfrm>
                <a:off x="666255" y="1334275"/>
                <a:ext cx="10887895" cy="842308"/>
                <a:chOff x="666255" y="1334275"/>
                <a:chExt cx="10887895" cy="842308"/>
              </a:xfrm>
            </p:grpSpPr>
            <p:grpSp>
              <p:nvGrpSpPr>
                <p:cNvPr id="9" name="Group 8"/>
                <p:cNvGrpSpPr/>
                <p:nvPr/>
              </p:nvGrpSpPr>
              <p:grpSpPr>
                <a:xfrm>
                  <a:off x="1021602" y="1791715"/>
                  <a:ext cx="10116524" cy="384868"/>
                  <a:chOff x="1459752" y="1791715"/>
                  <a:chExt cx="10116524" cy="384868"/>
                </a:xfrm>
              </p:grpSpPr>
              <p:grpSp>
                <p:nvGrpSpPr>
                  <p:cNvPr id="24" name="Group 23"/>
                  <p:cNvGrpSpPr/>
                  <p:nvPr/>
                </p:nvGrpSpPr>
                <p:grpSpPr>
                  <a:xfrm>
                    <a:off x="1459752" y="1791715"/>
                    <a:ext cx="10116524" cy="384468"/>
                    <a:chOff x="1409484" y="1800808"/>
                    <a:chExt cx="10116524" cy="384468"/>
                  </a:xfrm>
                </p:grpSpPr>
                <p:sp>
                  <p:nvSpPr>
                    <p:cNvPr id="37" name="Rectangle 36"/>
                    <p:cNvSpPr/>
                    <p:nvPr/>
                  </p:nvSpPr>
                  <p:spPr>
                    <a:xfrm>
                      <a:off x="1409484" y="1810372"/>
                      <a:ext cx="10113822" cy="374904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38" name="Straight Connector 37"/>
                    <p:cNvCxnSpPr/>
                    <p:nvPr/>
                  </p:nvCxnSpPr>
                  <p:spPr>
                    <a:xfrm>
                      <a:off x="1804642" y="1800808"/>
                      <a:ext cx="0" cy="382555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" name="Straight Connector 38"/>
                    <p:cNvCxnSpPr/>
                    <p:nvPr/>
                  </p:nvCxnSpPr>
                  <p:spPr>
                    <a:xfrm>
                      <a:off x="2268412" y="1800808"/>
                      <a:ext cx="0" cy="382555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0" name="Straight Connector 39"/>
                    <p:cNvCxnSpPr>
                      <a:stCxn id="42" idx="0"/>
                      <a:endCxn id="42" idx="2"/>
                    </p:cNvCxnSpPr>
                    <p:nvPr/>
                  </p:nvCxnSpPr>
                  <p:spPr>
                    <a:xfrm>
                      <a:off x="2266379" y="1800808"/>
                      <a:ext cx="0" cy="378729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1" name="Rectangle 40"/>
                    <p:cNvSpPr/>
                    <p:nvPr/>
                  </p:nvSpPr>
                  <p:spPr>
                    <a:xfrm>
                      <a:off x="1409485" y="1800808"/>
                      <a:ext cx="383348" cy="378729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42" name="Rectangle 41"/>
                    <p:cNvSpPr/>
                    <p:nvPr/>
                  </p:nvSpPr>
                  <p:spPr>
                    <a:xfrm>
                      <a:off x="2156440" y="1800808"/>
                      <a:ext cx="219878" cy="378729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43" name="Straight Connector 42"/>
                    <p:cNvCxnSpPr/>
                    <p:nvPr/>
                  </p:nvCxnSpPr>
                  <p:spPr>
                    <a:xfrm>
                      <a:off x="3917502" y="1810372"/>
                      <a:ext cx="0" cy="369165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" name="Straight Connector 43"/>
                    <p:cNvCxnSpPr/>
                    <p:nvPr/>
                  </p:nvCxnSpPr>
                  <p:spPr>
                    <a:xfrm>
                      <a:off x="3966106" y="1810372"/>
                      <a:ext cx="0" cy="369165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5" name="Rectangle 44"/>
                    <p:cNvSpPr/>
                    <p:nvPr/>
                  </p:nvSpPr>
                  <p:spPr>
                    <a:xfrm>
                      <a:off x="3786868" y="1800808"/>
                      <a:ext cx="179901" cy="378729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46" name="Rectangle 45"/>
                    <p:cNvSpPr/>
                    <p:nvPr/>
                  </p:nvSpPr>
                  <p:spPr>
                    <a:xfrm>
                      <a:off x="4417805" y="1810372"/>
                      <a:ext cx="79956" cy="369165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47" name="Rectangle 46"/>
                    <p:cNvSpPr/>
                    <p:nvPr/>
                  </p:nvSpPr>
                  <p:spPr>
                    <a:xfrm>
                      <a:off x="4898469" y="1810372"/>
                      <a:ext cx="121400" cy="369165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48" name="Rectangle 47"/>
                    <p:cNvSpPr/>
                    <p:nvPr/>
                  </p:nvSpPr>
                  <p:spPr>
                    <a:xfrm>
                      <a:off x="5766318" y="1810372"/>
                      <a:ext cx="187019" cy="369165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49" name="Rectangle 48"/>
                    <p:cNvSpPr/>
                    <p:nvPr/>
                  </p:nvSpPr>
                  <p:spPr>
                    <a:xfrm>
                      <a:off x="6428791" y="1810372"/>
                      <a:ext cx="65317" cy="369165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50" name="Rectangle 49"/>
                    <p:cNvSpPr/>
                    <p:nvPr/>
                  </p:nvSpPr>
                  <p:spPr>
                    <a:xfrm>
                      <a:off x="6988223" y="1810372"/>
                      <a:ext cx="224342" cy="369165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51" name="Rectangle 50"/>
                    <p:cNvSpPr/>
                    <p:nvPr/>
                  </p:nvSpPr>
                  <p:spPr>
                    <a:xfrm>
                      <a:off x="8892073" y="1810372"/>
                      <a:ext cx="177282" cy="369165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52" name="Rectangle 51"/>
                    <p:cNvSpPr/>
                    <p:nvPr/>
                  </p:nvSpPr>
                  <p:spPr>
                    <a:xfrm>
                      <a:off x="9601200" y="1810372"/>
                      <a:ext cx="130629" cy="369165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53" name="Rectangle 52"/>
                    <p:cNvSpPr/>
                    <p:nvPr/>
                  </p:nvSpPr>
                  <p:spPr>
                    <a:xfrm>
                      <a:off x="10273006" y="1810372"/>
                      <a:ext cx="130628" cy="369165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54" name="Rectangle 53"/>
                    <p:cNvSpPr/>
                    <p:nvPr/>
                  </p:nvSpPr>
                  <p:spPr>
                    <a:xfrm>
                      <a:off x="11246089" y="1810372"/>
                      <a:ext cx="279919" cy="369165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CA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25" name="Group 24"/>
                  <p:cNvGrpSpPr/>
                  <p:nvPr/>
                </p:nvGrpSpPr>
                <p:grpSpPr>
                  <a:xfrm>
                    <a:off x="1804642" y="1828800"/>
                    <a:ext cx="9245961" cy="347783"/>
                    <a:chOff x="1804642" y="1828800"/>
                    <a:chExt cx="9245961" cy="347783"/>
                  </a:xfrm>
                </p:grpSpPr>
                <p:sp>
                  <p:nvSpPr>
                    <p:cNvPr id="26" name="TextBox 25"/>
                    <p:cNvSpPr txBox="1"/>
                    <p:nvPr/>
                  </p:nvSpPr>
                  <p:spPr>
                    <a:xfrm>
                      <a:off x="1804642" y="1857375"/>
                      <a:ext cx="40427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CA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1</a:t>
                      </a:r>
                      <a:endParaRPr lang="en-CA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7" name="TextBox 26"/>
                    <p:cNvSpPr txBox="1"/>
                    <p:nvPr/>
                  </p:nvSpPr>
                  <p:spPr>
                    <a:xfrm>
                      <a:off x="2728115" y="1868806"/>
                      <a:ext cx="48707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CA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2</a:t>
                      </a:r>
                      <a:endParaRPr lang="en-CA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8" name="TextBox 27"/>
                    <p:cNvSpPr txBox="1"/>
                    <p:nvPr/>
                  </p:nvSpPr>
                  <p:spPr>
                    <a:xfrm>
                      <a:off x="4019562" y="1838325"/>
                      <a:ext cx="40427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CA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3</a:t>
                      </a:r>
                      <a:endParaRPr lang="en-CA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9" name="TextBox 28"/>
                    <p:cNvSpPr txBox="1"/>
                    <p:nvPr/>
                  </p:nvSpPr>
                  <p:spPr>
                    <a:xfrm>
                      <a:off x="4520968" y="1847850"/>
                      <a:ext cx="40427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CA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4</a:t>
                      </a:r>
                      <a:endParaRPr lang="en-CA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30" name="TextBox 29"/>
                    <p:cNvSpPr txBox="1"/>
                    <p:nvPr/>
                  </p:nvSpPr>
                  <p:spPr>
                    <a:xfrm>
                      <a:off x="5144641" y="1838325"/>
                      <a:ext cx="40427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CA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5</a:t>
                      </a:r>
                      <a:endParaRPr lang="en-CA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31" name="TextBox 30"/>
                    <p:cNvSpPr txBox="1"/>
                    <p:nvPr/>
                  </p:nvSpPr>
                  <p:spPr>
                    <a:xfrm>
                      <a:off x="6024053" y="1828800"/>
                      <a:ext cx="40427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CA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6</a:t>
                      </a:r>
                      <a:endParaRPr lang="en-CA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32" name="TextBox 31"/>
                    <p:cNvSpPr txBox="1"/>
                    <p:nvPr/>
                  </p:nvSpPr>
                  <p:spPr>
                    <a:xfrm>
                      <a:off x="6586203" y="1847850"/>
                      <a:ext cx="40427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CA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7</a:t>
                      </a:r>
                      <a:endParaRPr lang="en-CA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33" name="TextBox 32"/>
                    <p:cNvSpPr txBox="1"/>
                    <p:nvPr/>
                  </p:nvSpPr>
                  <p:spPr>
                    <a:xfrm>
                      <a:off x="7706680" y="1838325"/>
                      <a:ext cx="40427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CA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8</a:t>
                      </a:r>
                      <a:endParaRPr lang="en-CA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34" name="TextBox 33"/>
                    <p:cNvSpPr txBox="1"/>
                    <p:nvPr/>
                  </p:nvSpPr>
                  <p:spPr>
                    <a:xfrm>
                      <a:off x="9172575" y="1857375"/>
                      <a:ext cx="40427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CA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9</a:t>
                      </a:r>
                      <a:endParaRPr lang="en-CA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35" name="TextBox 34"/>
                    <p:cNvSpPr txBox="1"/>
                    <p:nvPr/>
                  </p:nvSpPr>
                  <p:spPr>
                    <a:xfrm>
                      <a:off x="9764818" y="1838325"/>
                      <a:ext cx="49404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CA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10</a:t>
                      </a:r>
                      <a:endParaRPr lang="en-CA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36" name="TextBox 35"/>
                    <p:cNvSpPr txBox="1"/>
                    <p:nvPr/>
                  </p:nvSpPr>
                  <p:spPr>
                    <a:xfrm>
                      <a:off x="10563225" y="1847850"/>
                      <a:ext cx="48737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CA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11</a:t>
                      </a:r>
                      <a:endParaRPr lang="en-CA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sp>
              <p:nvSpPr>
                <p:cNvPr id="10" name="TextBox 9"/>
                <p:cNvSpPr txBox="1"/>
                <p:nvPr/>
              </p:nvSpPr>
              <p:spPr>
                <a:xfrm>
                  <a:off x="666255" y="1850052"/>
                  <a:ext cx="333746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’</a:t>
                  </a:r>
                  <a:endParaRPr lang="en-CA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11142387" y="1823984"/>
                  <a:ext cx="333746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’</a:t>
                  </a:r>
                  <a:endParaRPr lang="en-CA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2" name="Straight Connector 11"/>
                <p:cNvCxnSpPr/>
                <p:nvPr/>
              </p:nvCxnSpPr>
              <p:spPr>
                <a:xfrm>
                  <a:off x="3021852" y="1628775"/>
                  <a:ext cx="0" cy="17203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/>
                <p:cNvCxnSpPr/>
                <p:nvPr/>
              </p:nvCxnSpPr>
              <p:spPr>
                <a:xfrm>
                  <a:off x="1022184" y="1619682"/>
                  <a:ext cx="0" cy="17203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Connector 13"/>
                <p:cNvCxnSpPr/>
                <p:nvPr/>
              </p:nvCxnSpPr>
              <p:spPr>
                <a:xfrm>
                  <a:off x="5022102" y="1619056"/>
                  <a:ext cx="0" cy="17203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/>
                <p:cNvCxnSpPr/>
                <p:nvPr/>
              </p:nvCxnSpPr>
              <p:spPr>
                <a:xfrm>
                  <a:off x="7012827" y="1609531"/>
                  <a:ext cx="0" cy="17203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Connector 15"/>
                <p:cNvCxnSpPr/>
                <p:nvPr/>
              </p:nvCxnSpPr>
              <p:spPr>
                <a:xfrm>
                  <a:off x="9073803" y="1619250"/>
                  <a:ext cx="0" cy="17203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/>
                <p:cNvCxnSpPr/>
                <p:nvPr/>
              </p:nvCxnSpPr>
              <p:spPr>
                <a:xfrm>
                  <a:off x="11139447" y="1638300"/>
                  <a:ext cx="0" cy="17203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" name="TextBox 17"/>
                <p:cNvSpPr txBox="1"/>
                <p:nvPr/>
              </p:nvSpPr>
              <p:spPr>
                <a:xfrm>
                  <a:off x="798350" y="1334275"/>
                  <a:ext cx="45878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 </a:t>
                  </a:r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t</a:t>
                  </a:r>
                  <a:endParaRPr lang="en-CA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2660142" y="1356040"/>
                  <a:ext cx="72808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00 nt</a:t>
                  </a:r>
                  <a:endParaRPr lang="en-CA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4712030" y="1340497"/>
                  <a:ext cx="72808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00 nt</a:t>
                  </a:r>
                  <a:endParaRPr lang="en-CA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6697640" y="1343608"/>
                  <a:ext cx="72808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0 nt</a:t>
                  </a:r>
                  <a:endParaRPr lang="en-CA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8724671" y="1346719"/>
                  <a:ext cx="72808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00 nt</a:t>
                  </a:r>
                  <a:endParaRPr lang="en-CA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10826066" y="1349830"/>
                  <a:ext cx="72808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00 nt</a:t>
                  </a:r>
                  <a:endParaRPr lang="en-CA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67" name="Group 66"/>
          <p:cNvGrpSpPr/>
          <p:nvPr/>
        </p:nvGrpSpPr>
        <p:grpSpPr>
          <a:xfrm>
            <a:off x="666255" y="3829470"/>
            <a:ext cx="4506037" cy="1728974"/>
            <a:chOff x="666729" y="4582502"/>
            <a:chExt cx="4506037" cy="1728974"/>
          </a:xfrm>
        </p:grpSpPr>
        <p:grpSp>
          <p:nvGrpSpPr>
            <p:cNvPr id="68" name="Group 67"/>
            <p:cNvGrpSpPr/>
            <p:nvPr/>
          </p:nvGrpSpPr>
          <p:grpSpPr>
            <a:xfrm>
              <a:off x="666729" y="5505257"/>
              <a:ext cx="4506037" cy="806219"/>
              <a:chOff x="666729" y="5505257"/>
              <a:chExt cx="4506037" cy="806219"/>
            </a:xfrm>
          </p:grpSpPr>
          <p:sp>
            <p:nvSpPr>
              <p:cNvPr id="76" name="TextBox 75"/>
              <p:cNvSpPr txBox="1"/>
              <p:nvPr/>
            </p:nvSpPr>
            <p:spPr>
              <a:xfrm>
                <a:off x="666729" y="5505257"/>
                <a:ext cx="3337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’</a:t>
                </a:r>
                <a:endParaRPr lang="en-CA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4839020" y="5543357"/>
                <a:ext cx="3337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’</a:t>
                </a:r>
                <a:endParaRPr lang="en-CA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8" name="Group 77"/>
              <p:cNvGrpSpPr/>
              <p:nvPr/>
            </p:nvGrpSpPr>
            <p:grpSpPr>
              <a:xfrm>
                <a:off x="838778" y="5524890"/>
                <a:ext cx="4009951" cy="786586"/>
                <a:chOff x="838778" y="5524890"/>
                <a:chExt cx="4009951" cy="786586"/>
              </a:xfrm>
            </p:grpSpPr>
            <p:sp>
              <p:nvSpPr>
                <p:cNvPr id="79" name="Rectangle 78"/>
                <p:cNvSpPr/>
                <p:nvPr/>
              </p:nvSpPr>
              <p:spPr>
                <a:xfrm>
                  <a:off x="1051520" y="5524890"/>
                  <a:ext cx="3797209" cy="373462"/>
                </a:xfrm>
                <a:prstGeom prst="rect">
                  <a:avLst/>
                </a:prstGeom>
                <a:solidFill>
                  <a:schemeClr val="accent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80" name="Straight Connector 79"/>
                <p:cNvCxnSpPr/>
                <p:nvPr/>
              </p:nvCxnSpPr>
              <p:spPr>
                <a:xfrm>
                  <a:off x="1053286" y="5911579"/>
                  <a:ext cx="0" cy="17203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Straight Connector 80"/>
                <p:cNvCxnSpPr/>
                <p:nvPr/>
              </p:nvCxnSpPr>
              <p:spPr>
                <a:xfrm>
                  <a:off x="3024958" y="5906406"/>
                  <a:ext cx="0" cy="17203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2" name="TextBox 81"/>
                <p:cNvSpPr txBox="1"/>
                <p:nvPr/>
              </p:nvSpPr>
              <p:spPr>
                <a:xfrm>
                  <a:off x="838778" y="6003699"/>
                  <a:ext cx="458780" cy="307777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 </a:t>
                  </a:r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t</a:t>
                  </a:r>
                  <a:endParaRPr lang="en-CA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2829315" y="5985410"/>
                  <a:ext cx="728084" cy="307777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00 nt</a:t>
                  </a:r>
                  <a:endParaRPr lang="en-CA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84" name="Straight Connector 83"/>
                <p:cNvCxnSpPr/>
                <p:nvPr/>
              </p:nvCxnSpPr>
              <p:spPr>
                <a:xfrm>
                  <a:off x="2035091" y="5902734"/>
                  <a:ext cx="0" cy="17203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Straight Connector 84"/>
                <p:cNvCxnSpPr/>
                <p:nvPr/>
              </p:nvCxnSpPr>
              <p:spPr>
                <a:xfrm>
                  <a:off x="4029923" y="5906406"/>
                  <a:ext cx="0" cy="17203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6" name="TextBox 85"/>
                <p:cNvSpPr txBox="1"/>
                <p:nvPr/>
              </p:nvSpPr>
              <p:spPr>
                <a:xfrm>
                  <a:off x="1812279" y="6002963"/>
                  <a:ext cx="638316" cy="307777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0 </a:t>
                  </a:r>
                  <a:r>
                    <a:rPr lang="en-CA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t</a:t>
                  </a:r>
                  <a:endParaRPr lang="en-CA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TextBox 86"/>
                <p:cNvSpPr txBox="1"/>
                <p:nvPr/>
              </p:nvSpPr>
              <p:spPr>
                <a:xfrm>
                  <a:off x="3827784" y="5984287"/>
                  <a:ext cx="728084" cy="307777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lang="en-CA" sz="140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00 nt</a:t>
                  </a:r>
                  <a:endParaRPr lang="en-CA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69" name="Group 68"/>
            <p:cNvGrpSpPr/>
            <p:nvPr/>
          </p:nvGrpSpPr>
          <p:grpSpPr>
            <a:xfrm>
              <a:off x="1859525" y="4582502"/>
              <a:ext cx="2419701" cy="933054"/>
              <a:chOff x="1859525" y="4050659"/>
              <a:chExt cx="2419701" cy="933054"/>
            </a:xfrm>
          </p:grpSpPr>
          <p:cxnSp>
            <p:nvCxnSpPr>
              <p:cNvPr id="70" name="Straight Arrow Connector 69"/>
              <p:cNvCxnSpPr/>
              <p:nvPr/>
            </p:nvCxnSpPr>
            <p:spPr>
              <a:xfrm>
                <a:off x="2204166" y="4478305"/>
                <a:ext cx="0" cy="505408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Arrow Connector 70"/>
              <p:cNvCxnSpPr/>
              <p:nvPr/>
            </p:nvCxnSpPr>
            <p:spPr>
              <a:xfrm>
                <a:off x="3198995" y="4473639"/>
                <a:ext cx="0" cy="505408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Arrow Connector 71"/>
              <p:cNvCxnSpPr/>
              <p:nvPr/>
            </p:nvCxnSpPr>
            <p:spPr>
              <a:xfrm>
                <a:off x="4035197" y="4461286"/>
                <a:ext cx="0" cy="505408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TextBox 72"/>
              <p:cNvSpPr txBox="1"/>
              <p:nvPr/>
            </p:nvSpPr>
            <p:spPr>
              <a:xfrm>
                <a:off x="1859525" y="4063105"/>
                <a:ext cx="61266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S-1</a:t>
                </a:r>
                <a:endParaRPr lang="en-CA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2842354" y="4066200"/>
                <a:ext cx="61266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S-2</a:t>
                </a:r>
                <a:endParaRPr lang="en-CA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3666558" y="4050659"/>
                <a:ext cx="61266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S-3</a:t>
                </a:r>
                <a:endParaRPr lang="en-CA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88" name="TextBox 87"/>
          <p:cNvSpPr txBox="1"/>
          <p:nvPr/>
        </p:nvSpPr>
        <p:spPr>
          <a:xfrm>
            <a:off x="258145" y="484094"/>
            <a:ext cx="34657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en-CA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258145" y="3551516"/>
            <a:ext cx="336952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CA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093164" y="6481482"/>
            <a:ext cx="2005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gure 2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8184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56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ya</dc:creator>
  <cp:lastModifiedBy>Carita</cp:lastModifiedBy>
  <cp:revision>6</cp:revision>
  <dcterms:created xsi:type="dcterms:W3CDTF">2015-04-08T23:32:16Z</dcterms:created>
  <dcterms:modified xsi:type="dcterms:W3CDTF">2015-11-17T21:10:43Z</dcterms:modified>
</cp:coreProperties>
</file>